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4"/>
  </p:notesMasterIdLst>
  <p:handoutMasterIdLst>
    <p:handoutMasterId r:id="rId5"/>
  </p:handoutMasterIdLst>
  <p:sldIdLst>
    <p:sldId id="396" r:id="rId2"/>
    <p:sldId id="397" r:id="rId3"/>
  </p:sldIdLst>
  <p:sldSz cx="12192000" cy="6858000"/>
  <p:notesSz cx="9928225" cy="6797675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3333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034" autoAdjust="0"/>
    <p:restoredTop sz="94404" autoAdjust="0"/>
  </p:normalViewPr>
  <p:slideViewPr>
    <p:cSldViewPr snapToGrid="0">
      <p:cViewPr varScale="1">
        <p:scale>
          <a:sx n="80" d="100"/>
          <a:sy n="80" d="100"/>
        </p:scale>
        <p:origin x="58" y="226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4303313" cy="34129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quarter" idx="1"/>
          </p:nvPr>
        </p:nvSpPr>
        <p:spPr>
          <a:xfrm>
            <a:off x="5622594" y="2"/>
            <a:ext cx="4303313" cy="34129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AF07FB4-1BBF-45E7-839D-23EC12C90DF5}" type="datetimeFigureOut">
              <a:rPr lang="zh-TW" altLang="en-US" smtClean="0"/>
              <a:t>2023/9/27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2"/>
          </p:nvPr>
        </p:nvSpPr>
        <p:spPr>
          <a:xfrm>
            <a:off x="0" y="6456380"/>
            <a:ext cx="4303313" cy="34129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3"/>
          </p:nvPr>
        </p:nvSpPr>
        <p:spPr>
          <a:xfrm>
            <a:off x="5622594" y="6456380"/>
            <a:ext cx="4303313" cy="34129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CEDB775-D806-4765-93AE-1EB5168EE04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5434223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3" y="0"/>
            <a:ext cx="4302231" cy="3410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5623700" y="0"/>
            <a:ext cx="4302231" cy="3410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94D560-1906-4008-84E6-2CA8AC7F4D75}" type="datetimeFigureOut">
              <a:rPr lang="zh-TW" altLang="en-US" smtClean="0"/>
              <a:t>2023/9/27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2925763" y="849313"/>
            <a:ext cx="4076700" cy="229393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992823" y="3271383"/>
            <a:ext cx="7942580" cy="267658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3" y="6456613"/>
            <a:ext cx="4302231" cy="3410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5623700" y="6456613"/>
            <a:ext cx="4302231" cy="3410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4CBE8E6-A870-4E49-946C-A827C617A7B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1171051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4CBE8E6-A870-4E49-946C-A827C617A7B8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86962626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4CBE8E6-A870-4E49-946C-A827C617A7B8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64356398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A765D28F-E2F0-46E5-8180-D306B2AA3F0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>
            <a:extLst>
              <a:ext uri="{FF2B5EF4-FFF2-40B4-BE49-F238E27FC236}">
                <a16:creationId xmlns:a16="http://schemas.microsoft.com/office/drawing/2014/main" id="{943CAB50-1441-4252-ACB1-F7C0EB39EF9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子標題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ED662B3F-A0D5-4E3A-A730-F596051390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1D3E9BDC-D474-4C6E-B0F8-B62424A6991F}" type="datetime1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Times New Roman"/>
                <a:ea typeface="標楷體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Times New Roman"/>
              <a:ea typeface="標楷體"/>
              <a:cs typeface="+mn-cs"/>
            </a:endParaRPr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60671ED9-315A-4818-88CA-F54E634E5E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Times New Roman"/>
              <a:ea typeface="標楷體"/>
              <a:cs typeface="+mn-cs"/>
            </a:endParaRPr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161104E8-3A48-467A-A71D-07CACFED4B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70A55453-903A-4987-B4A6-5374555ED92F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Times New Roman"/>
                <a:ea typeface="標楷體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Times New Roman"/>
              <a:ea typeface="標楷體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42212985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3298E2C2-AD9B-4162-9339-0CD485481B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80046886-87F4-47AB-A2BE-36AF31C35EE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98E51BF8-39DA-463E-BFB7-798036D2B8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9B463338-36FA-4537-9295-F1766BD6F294}" type="datetime1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Times New Roman"/>
                <a:ea typeface="標楷體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Times New Roman"/>
              <a:ea typeface="標楷體"/>
              <a:cs typeface="+mn-cs"/>
            </a:endParaRPr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443A8F5A-06B4-414E-8A52-B8E72AE5CB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Times New Roman"/>
              <a:ea typeface="標楷體"/>
              <a:cs typeface="+mn-cs"/>
            </a:endParaRPr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27580FAD-D8C1-4393-AEB9-B4EF7375A9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70A55453-903A-4987-B4A6-5374555ED92F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Times New Roman"/>
                <a:ea typeface="標楷體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Times New Roman"/>
              <a:ea typeface="標楷體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42205509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>
            <a:extLst>
              <a:ext uri="{FF2B5EF4-FFF2-40B4-BE49-F238E27FC236}">
                <a16:creationId xmlns:a16="http://schemas.microsoft.com/office/drawing/2014/main" id="{ABAEBDCB-F53A-41AE-8808-87A085CC37C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6F211501-F34B-45CE-8DB6-943A2A7EA54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1E003AC0-DC3D-4C7F-8C02-F1FCEC78DA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21C240EE-BD87-45D8-8DC0-6CFF54844980}" type="datetime1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Times New Roman"/>
                <a:ea typeface="標楷體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Times New Roman"/>
              <a:ea typeface="標楷體"/>
              <a:cs typeface="+mn-cs"/>
            </a:endParaRPr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CDC14267-3817-4FF5-B652-E67B654D2B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Times New Roman"/>
              <a:ea typeface="標楷體"/>
              <a:cs typeface="+mn-cs"/>
            </a:endParaRPr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58E686C4-9DAE-4092-B652-F05F9BF18A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70A55453-903A-4987-B4A6-5374555ED92F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Times New Roman"/>
                <a:ea typeface="標楷體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Times New Roman"/>
              <a:ea typeface="標楷體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8558075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A5EDEDF2-05BD-41D7-8581-CE59D01AE0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E7E5D348-ABB7-4769-9987-B95EF7C1897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C1B3DF9B-1B0E-4E27-B55D-031A1D9DAE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1FBED71-0AB0-4A11-9FB3-30C2D65F384A}" type="datetime1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Times New Roman"/>
                <a:ea typeface="標楷體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Times New Roman"/>
              <a:ea typeface="標楷體"/>
              <a:cs typeface="+mn-cs"/>
            </a:endParaRPr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EF98A0FE-7363-4339-84D0-CB3DF01669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Times New Roman"/>
              <a:ea typeface="標楷體"/>
              <a:cs typeface="+mn-cs"/>
            </a:endParaRPr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2ACC2F46-6ED2-4F5A-99F6-83F5D90137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70A55453-903A-4987-B4A6-5374555ED92F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Times New Roman"/>
                <a:ea typeface="標楷體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Times New Roman"/>
              <a:ea typeface="標楷體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2850596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45DE2352-86AD-457A-ADD1-2CA05AB874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80E4D8D3-F2D8-4ACE-9B05-F81AD5AFAF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B50DB93D-432F-4401-AFB3-D21A15D86B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60B60C4-286B-4EB8-B4DB-67EC1BAB476A}" type="datetime1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Times New Roman"/>
                <a:ea typeface="標楷體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Times New Roman"/>
              <a:ea typeface="標楷體"/>
              <a:cs typeface="+mn-cs"/>
            </a:endParaRPr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38A1324A-DD56-4304-B5E7-2487647DD5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Times New Roman"/>
              <a:ea typeface="標楷體"/>
              <a:cs typeface="+mn-cs"/>
            </a:endParaRPr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BC9AAC98-70F1-4C3E-B1DF-8F3CC4C18E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70A55453-903A-4987-B4A6-5374555ED92F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Times New Roman"/>
                <a:ea typeface="標楷體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Times New Roman"/>
              <a:ea typeface="標楷體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7845686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0D46366A-C4E7-4933-A853-2731A9732A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3F50B4BD-B7CE-47CB-B35C-B1507B98519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EB43F8C1-97A9-453E-89D7-9BDF03B7280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4DA3BE47-2560-480A-9623-62E44D6B31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00BF13A3-6FDD-4BAE-A2ED-3831E9F92C12}" type="datetime1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Times New Roman"/>
                <a:ea typeface="標楷體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Times New Roman"/>
              <a:ea typeface="標楷體"/>
              <a:cs typeface="+mn-cs"/>
            </a:endParaRPr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F6F16975-9BFD-46C6-8F15-C9779F8BE1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Times New Roman"/>
              <a:ea typeface="標楷體"/>
              <a:cs typeface="+mn-cs"/>
            </a:endParaRPr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FA36E0E4-4DB3-448F-BA91-86C07D8F1A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70A55453-903A-4987-B4A6-5374555ED92F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Times New Roman"/>
                <a:ea typeface="標楷體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Times New Roman"/>
              <a:ea typeface="標楷體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9213886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ACF3736F-65CF-4795-A436-0D1499E6E4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C999C17E-F723-464C-94E2-DA99BED8B3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883E6842-776B-4D49-8392-5900BD5A482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>
            <a:extLst>
              <a:ext uri="{FF2B5EF4-FFF2-40B4-BE49-F238E27FC236}">
                <a16:creationId xmlns:a16="http://schemas.microsoft.com/office/drawing/2014/main" id="{1385DED5-D966-49AD-B28D-4EE5DCC1529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6" name="內容版面配置區 5">
            <a:extLst>
              <a:ext uri="{FF2B5EF4-FFF2-40B4-BE49-F238E27FC236}">
                <a16:creationId xmlns:a16="http://schemas.microsoft.com/office/drawing/2014/main" id="{A84A2654-0FB7-4D48-8CC3-142009F052E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>
            <a:extLst>
              <a:ext uri="{FF2B5EF4-FFF2-40B4-BE49-F238E27FC236}">
                <a16:creationId xmlns:a16="http://schemas.microsoft.com/office/drawing/2014/main" id="{ACB2BFC9-E323-4001-9696-74740A95A8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D106E02D-B2AA-4506-9B1A-1FE500303F0F}" type="datetime1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Times New Roman"/>
                <a:ea typeface="標楷體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Times New Roman"/>
              <a:ea typeface="標楷體"/>
              <a:cs typeface="+mn-cs"/>
            </a:endParaRPr>
          </a:p>
        </p:txBody>
      </p:sp>
      <p:sp>
        <p:nvSpPr>
          <p:cNvPr id="8" name="頁尾版面配置區 7">
            <a:extLst>
              <a:ext uri="{FF2B5EF4-FFF2-40B4-BE49-F238E27FC236}">
                <a16:creationId xmlns:a16="http://schemas.microsoft.com/office/drawing/2014/main" id="{2DAB2F8F-37E6-47C1-A1B3-ABBB59D5AB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Times New Roman"/>
              <a:ea typeface="標楷體"/>
              <a:cs typeface="+mn-cs"/>
            </a:endParaRPr>
          </a:p>
        </p:txBody>
      </p:sp>
      <p:sp>
        <p:nvSpPr>
          <p:cNvPr id="9" name="投影片編號版面配置區 8">
            <a:extLst>
              <a:ext uri="{FF2B5EF4-FFF2-40B4-BE49-F238E27FC236}">
                <a16:creationId xmlns:a16="http://schemas.microsoft.com/office/drawing/2014/main" id="{576B890D-8426-4E00-A332-2A92A2AD8B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70A55453-903A-4987-B4A6-5374555ED92F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Times New Roman"/>
                <a:ea typeface="標楷體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Times New Roman"/>
              <a:ea typeface="標楷體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9829877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762B401C-EAE9-49C2-ADDF-AC4C99CAB8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>
            <a:extLst>
              <a:ext uri="{FF2B5EF4-FFF2-40B4-BE49-F238E27FC236}">
                <a16:creationId xmlns:a16="http://schemas.microsoft.com/office/drawing/2014/main" id="{E2D0A576-CA38-46A7-908F-4E496CE5B4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D503620-7A8C-412D-BA58-ED1A2C12CA39}" type="datetime1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Times New Roman"/>
                <a:ea typeface="標楷體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Times New Roman"/>
              <a:ea typeface="標楷體"/>
              <a:cs typeface="+mn-cs"/>
            </a:endParaRPr>
          </a:p>
        </p:txBody>
      </p:sp>
      <p:sp>
        <p:nvSpPr>
          <p:cNvPr id="4" name="頁尾版面配置區 3">
            <a:extLst>
              <a:ext uri="{FF2B5EF4-FFF2-40B4-BE49-F238E27FC236}">
                <a16:creationId xmlns:a16="http://schemas.microsoft.com/office/drawing/2014/main" id="{887BB3EA-CB11-4852-90B7-FF97E115B3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Times New Roman"/>
              <a:ea typeface="標楷體"/>
              <a:cs typeface="+mn-cs"/>
            </a:endParaRPr>
          </a:p>
        </p:txBody>
      </p:sp>
      <p:sp>
        <p:nvSpPr>
          <p:cNvPr id="5" name="投影片編號版面配置區 4">
            <a:extLst>
              <a:ext uri="{FF2B5EF4-FFF2-40B4-BE49-F238E27FC236}">
                <a16:creationId xmlns:a16="http://schemas.microsoft.com/office/drawing/2014/main" id="{665F3065-89E3-4AB0-B942-DA1B44BE38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70A55453-903A-4987-B4A6-5374555ED92F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Times New Roman"/>
                <a:ea typeface="標楷體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Times New Roman"/>
              <a:ea typeface="標楷體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3047491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>
            <a:extLst>
              <a:ext uri="{FF2B5EF4-FFF2-40B4-BE49-F238E27FC236}">
                <a16:creationId xmlns:a16="http://schemas.microsoft.com/office/drawing/2014/main" id="{7EFBF214-3D48-4C2E-9EC9-AD5B88BE87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E3AE1285-963A-4893-A61E-193F8560ED1F}" type="datetime1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Times New Roman"/>
                <a:ea typeface="標楷體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Times New Roman"/>
              <a:ea typeface="標楷體"/>
              <a:cs typeface="+mn-cs"/>
            </a:endParaRPr>
          </a:p>
        </p:txBody>
      </p:sp>
      <p:sp>
        <p:nvSpPr>
          <p:cNvPr id="3" name="頁尾版面配置區 2">
            <a:extLst>
              <a:ext uri="{FF2B5EF4-FFF2-40B4-BE49-F238E27FC236}">
                <a16:creationId xmlns:a16="http://schemas.microsoft.com/office/drawing/2014/main" id="{BC71E045-B1BE-4ACC-9D3E-A1E361437D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Times New Roman"/>
              <a:ea typeface="標楷體"/>
              <a:cs typeface="+mn-cs"/>
            </a:endParaRPr>
          </a:p>
        </p:txBody>
      </p:sp>
      <p:sp>
        <p:nvSpPr>
          <p:cNvPr id="4" name="投影片編號版面配置區 3">
            <a:extLst>
              <a:ext uri="{FF2B5EF4-FFF2-40B4-BE49-F238E27FC236}">
                <a16:creationId xmlns:a16="http://schemas.microsoft.com/office/drawing/2014/main" id="{77DC5954-888A-4801-BB30-7E128334ED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70A55453-903A-4987-B4A6-5374555ED92F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Times New Roman"/>
                <a:ea typeface="標楷體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Times New Roman"/>
              <a:ea typeface="標楷體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6235691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AA7576B0-5E24-4C30-9084-5B2D7B3AF1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00348CC0-079B-4CA4-834C-C8397658947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890E2A84-8C1D-43E2-A906-DAD03A16155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AC2BB8EC-D90F-4D99-B69A-A14944D2C6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BC575C0-2921-4AC2-B943-4A78D8DA45A8}" type="datetime1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Times New Roman"/>
                <a:ea typeface="標楷體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Times New Roman"/>
              <a:ea typeface="標楷體"/>
              <a:cs typeface="+mn-cs"/>
            </a:endParaRPr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303BD183-7235-4CE5-8321-EE0B265A93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Times New Roman"/>
              <a:ea typeface="標楷體"/>
              <a:cs typeface="+mn-cs"/>
            </a:endParaRPr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223A99F8-042A-4130-8B8E-E2C5B66636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70A55453-903A-4987-B4A6-5374555ED92F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Times New Roman"/>
                <a:ea typeface="標楷體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Times New Roman"/>
              <a:ea typeface="標楷體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2760696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19D3FDBD-5D82-4756-9B3D-58B60D109A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>
            <a:extLst>
              <a:ext uri="{FF2B5EF4-FFF2-40B4-BE49-F238E27FC236}">
                <a16:creationId xmlns:a16="http://schemas.microsoft.com/office/drawing/2014/main" id="{FE4975C6-BBA3-4FD0-AEF8-DA4B01C9B7A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60ECDADC-ECF9-4E1A-A946-F4A887A4DA6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FCF39EE1-730B-4D01-BB65-7B4675A0B1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FEEA5CD4-3AE9-43C4-86DB-4A007A5B6856}" type="datetime1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Times New Roman"/>
                <a:ea typeface="標楷體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Times New Roman"/>
              <a:ea typeface="標楷體"/>
              <a:cs typeface="+mn-cs"/>
            </a:endParaRPr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D23A0FC1-E73E-4A51-931A-5297608704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Times New Roman"/>
              <a:ea typeface="標楷體"/>
              <a:cs typeface="+mn-cs"/>
            </a:endParaRPr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3EA60B10-49D6-4718-A6F9-3B72898672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70A55453-903A-4987-B4A6-5374555ED92F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Times New Roman"/>
                <a:ea typeface="標楷體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Times New Roman"/>
              <a:ea typeface="標楷體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4562117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>
            <a:extLst>
              <a:ext uri="{FF2B5EF4-FFF2-40B4-BE49-F238E27FC236}">
                <a16:creationId xmlns:a16="http://schemas.microsoft.com/office/drawing/2014/main" id="{FCDEE1E7-CE34-4785-8332-C472A6371E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8256"/>
            <a:ext cx="10515600" cy="77134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dirty="0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856E7ADB-8672-4A6B-B8AA-0AB6D1FA52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861060"/>
            <a:ext cx="10515600" cy="531590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E4D1C892-49C5-4478-90AF-36E6D74A22D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B72DCD8-9B65-41FE-AB1F-EF99AE48D64C}" type="datetime1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Times New Roman"/>
                <a:ea typeface="標楷體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Times New Roman"/>
              <a:ea typeface="標楷體"/>
              <a:cs typeface="+mn-cs"/>
            </a:endParaRPr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7DD2620A-D102-4402-838E-B7607081A32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Times New Roman"/>
              <a:ea typeface="標楷體"/>
              <a:cs typeface="+mn-cs"/>
            </a:endParaRPr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C6F213E5-CBF7-40B2-A291-41C970064A9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70A55453-903A-4987-B4A6-5374555ED92F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Times New Roman"/>
                <a:ea typeface="標楷體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Times New Roman"/>
              <a:ea typeface="標楷體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9060010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hf hdr="0" ftr="0" dt="0"/>
  <p:txStyles>
    <p:titleStyle>
      <a:lvl1pPr algn="ctr" defTabSz="914400" rtl="0" eaLnBrk="1" latinLnBrk="0" hangingPunct="1">
        <a:lnSpc>
          <a:spcPct val="90000"/>
        </a:lnSpc>
        <a:spcBef>
          <a:spcPct val="0"/>
        </a:spcBef>
        <a:buNone/>
        <a:defRPr sz="3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/>
          <p:cNvSpPr/>
          <p:nvPr/>
        </p:nvSpPr>
        <p:spPr>
          <a:xfrm>
            <a:off x="1924051" y="3019612"/>
            <a:ext cx="858202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69875" indent="-269875" algn="just">
              <a:spcAft>
                <a:spcPts val="0"/>
              </a:spcAft>
            </a:pPr>
            <a:r>
              <a:rPr lang="en-US" altLang="zh-TW" b="1" dirty="0">
                <a:solidFill>
                  <a:srgbClr val="0000FF"/>
                </a:solidFill>
                <a:latin typeface="Calibri" panose="020F0502020204030204" pitchFamily="34" charset="0"/>
                <a:ea typeface="新細明體" panose="02020500000000000000" pitchFamily="18" charset="-120"/>
              </a:rPr>
              <a:t>S1 Fig. </a:t>
            </a:r>
            <a:r>
              <a:rPr lang="en-US" altLang="zh-TW" dirty="0">
                <a:solidFill>
                  <a:srgbClr val="0000FF"/>
                </a:solidFill>
                <a:latin typeface="Calibri" panose="020F0502020204030204" pitchFamily="34" charset="0"/>
                <a:ea typeface="新細明體" panose="02020500000000000000" pitchFamily="18" charset="-120"/>
              </a:rPr>
              <a:t>Schematic diagrams of the </a:t>
            </a:r>
            <a:r>
              <a:rPr lang="en-US" altLang="zh-TW" i="1" dirty="0">
                <a:solidFill>
                  <a:srgbClr val="0000FF"/>
                </a:solidFill>
                <a:latin typeface="Calibri" panose="020F0502020204030204" pitchFamily="34" charset="0"/>
                <a:ea typeface="新細明體" panose="02020500000000000000" pitchFamily="18" charset="-120"/>
              </a:rPr>
              <a:t>OsGA3ox1</a:t>
            </a:r>
            <a:r>
              <a:rPr lang="en-US" altLang="zh-TW" dirty="0">
                <a:solidFill>
                  <a:srgbClr val="0000FF"/>
                </a:solidFill>
                <a:latin typeface="Calibri" panose="020F0502020204030204" pitchFamily="34" charset="0"/>
                <a:ea typeface="新細明體" panose="02020500000000000000" pitchFamily="18" charset="-120"/>
              </a:rPr>
              <a:t> gene structures, </a:t>
            </a:r>
            <a:r>
              <a:rPr lang="en-US" altLang="zh-TW" dirty="0" err="1">
                <a:solidFill>
                  <a:srgbClr val="0000FF"/>
                </a:solidFill>
                <a:latin typeface="Calibri" panose="020F0502020204030204" pitchFamily="34" charset="0"/>
                <a:ea typeface="新細明體" panose="02020500000000000000" pitchFamily="18" charset="-120"/>
              </a:rPr>
              <a:t>sgRNA</a:t>
            </a:r>
            <a:r>
              <a:rPr lang="en-US" altLang="zh-TW" dirty="0">
                <a:solidFill>
                  <a:srgbClr val="0000FF"/>
                </a:solidFill>
                <a:latin typeface="Calibri" panose="020F0502020204030204" pitchFamily="34" charset="0"/>
                <a:ea typeface="新細明體" panose="02020500000000000000" pitchFamily="18" charset="-120"/>
              </a:rPr>
              <a:t> target sites and the template vector pRGEB32 and analysis of the Cas9-induced </a:t>
            </a:r>
            <a:r>
              <a:rPr lang="en-US" altLang="zh-TW" i="1" dirty="0">
                <a:solidFill>
                  <a:srgbClr val="0000FF"/>
                </a:solidFill>
                <a:latin typeface="Calibri" panose="020F0502020204030204" pitchFamily="34" charset="0"/>
                <a:ea typeface="新細明體" panose="02020500000000000000" pitchFamily="18" charset="-120"/>
              </a:rPr>
              <a:t>osga3ox1</a:t>
            </a:r>
            <a:r>
              <a:rPr lang="en-US" altLang="zh-TW" dirty="0">
                <a:solidFill>
                  <a:srgbClr val="0000FF"/>
                </a:solidFill>
                <a:latin typeface="Calibri" panose="020F0502020204030204" pitchFamily="34" charset="0"/>
                <a:ea typeface="新細明體" panose="02020500000000000000" pitchFamily="18" charset="-120"/>
              </a:rPr>
              <a:t> variants</a:t>
            </a:r>
            <a:endParaRPr lang="zh-TW" altLang="zh-TW" kern="100" dirty="0">
              <a:latin typeface="Calibri" panose="020F0502020204030204" pitchFamily="34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232099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字方塊 7"/>
          <p:cNvSpPr txBox="1"/>
          <p:nvPr/>
        </p:nvSpPr>
        <p:spPr>
          <a:xfrm>
            <a:off x="53197" y="24387"/>
            <a:ext cx="795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800" b="1" i="0" u="none" strike="noStrike" kern="1200" cap="none" spc="0" normalizeH="0" baseline="0" noProof="0" dirty="0">
                <a:ln>
                  <a:noFill/>
                </a:ln>
                <a:solidFill>
                  <a:srgbClr val="0000FF"/>
                </a:solidFill>
                <a:effectLst/>
                <a:uLnTx/>
                <a:uFillTx/>
                <a:latin typeface="Calibri" panose="020F0502020204030204" pitchFamily="34" charset="0"/>
                <a:ea typeface="標楷體"/>
                <a:cs typeface="Calibri" panose="020F0502020204030204" pitchFamily="34" charset="0"/>
              </a:rPr>
              <a:t>Fig. S1</a:t>
            </a:r>
            <a:endParaRPr kumimoji="0" lang="zh-TW" altLang="en-US" sz="1800" b="1" i="0" u="none" strike="noStrike" kern="1200" cap="none" spc="0" normalizeH="0" baseline="0" noProof="0" dirty="0">
              <a:ln>
                <a:noFill/>
              </a:ln>
              <a:solidFill>
                <a:srgbClr val="0000FF"/>
              </a:solidFill>
              <a:effectLst/>
              <a:uLnTx/>
              <a:uFillTx/>
              <a:latin typeface="Calibri" panose="020F0502020204030204" pitchFamily="34" charset="0"/>
              <a:ea typeface="標楷體"/>
              <a:cs typeface="Calibri" panose="020F0502020204030204" pitchFamily="34" charset="0"/>
            </a:endParaRPr>
          </a:p>
        </p:txBody>
      </p:sp>
      <p:grpSp>
        <p:nvGrpSpPr>
          <p:cNvPr id="17" name="群組 16"/>
          <p:cNvGrpSpPr/>
          <p:nvPr/>
        </p:nvGrpSpPr>
        <p:grpSpPr>
          <a:xfrm>
            <a:off x="895429" y="192815"/>
            <a:ext cx="10986565" cy="6539683"/>
            <a:chOff x="920596" y="137391"/>
            <a:chExt cx="10986565" cy="6539683"/>
          </a:xfrm>
        </p:grpSpPr>
        <p:sp>
          <p:nvSpPr>
            <p:cNvPr id="42" name="文字方塊 41"/>
            <p:cNvSpPr txBox="1"/>
            <p:nvPr/>
          </p:nvSpPr>
          <p:spPr>
            <a:xfrm>
              <a:off x="936626" y="1967203"/>
              <a:ext cx="35779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標楷體"/>
                  <a:cs typeface="Calibri" panose="020F0502020204030204" pitchFamily="34" charset="0"/>
                </a:rPr>
                <a:t>C)</a:t>
              </a:r>
              <a:endParaRPr kumimoji="0" lang="zh-TW" altLang="en-US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標楷體"/>
                <a:cs typeface="Calibri" panose="020F0502020204030204" pitchFamily="34" charset="0"/>
              </a:endParaRPr>
            </a:p>
          </p:txBody>
        </p:sp>
        <p:grpSp>
          <p:nvGrpSpPr>
            <p:cNvPr id="13" name="群組 12"/>
            <p:cNvGrpSpPr/>
            <p:nvPr/>
          </p:nvGrpSpPr>
          <p:grpSpPr>
            <a:xfrm>
              <a:off x="6500427" y="137391"/>
              <a:ext cx="5300780" cy="1416173"/>
              <a:chOff x="6500427" y="137391"/>
              <a:chExt cx="5300780" cy="1416173"/>
            </a:xfrm>
          </p:grpSpPr>
          <p:sp>
            <p:nvSpPr>
              <p:cNvPr id="41" name="文字方塊 40"/>
              <p:cNvSpPr txBox="1"/>
              <p:nvPr/>
            </p:nvSpPr>
            <p:spPr>
              <a:xfrm>
                <a:off x="6500427" y="137391"/>
                <a:ext cx="36420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TW" sz="1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標楷體"/>
                    <a:cs typeface="Calibri" panose="020F0502020204030204" pitchFamily="34" charset="0"/>
                  </a:rPr>
                  <a:t>B)</a:t>
                </a:r>
                <a:endParaRPr kumimoji="0" lang="zh-TW" altLang="en-US" sz="1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標楷體"/>
                  <a:cs typeface="Calibri" panose="020F0502020204030204" pitchFamily="34" charset="0"/>
                </a:endParaRPr>
              </a:p>
            </p:txBody>
          </p:sp>
          <p:pic>
            <p:nvPicPr>
              <p:cNvPr id="2" name="圖片 1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6810355" y="302996"/>
                <a:ext cx="4990852" cy="1250568"/>
              </a:xfrm>
              <a:prstGeom prst="rect">
                <a:avLst/>
              </a:prstGeom>
            </p:spPr>
          </p:pic>
        </p:grpSp>
        <p:grpSp>
          <p:nvGrpSpPr>
            <p:cNvPr id="9" name="群組 8"/>
            <p:cNvGrpSpPr/>
            <p:nvPr/>
          </p:nvGrpSpPr>
          <p:grpSpPr>
            <a:xfrm>
              <a:off x="6460393" y="1900091"/>
              <a:ext cx="5446768" cy="2280111"/>
              <a:chOff x="6460393" y="1900091"/>
              <a:chExt cx="5446768" cy="2280111"/>
            </a:xfrm>
          </p:grpSpPr>
          <p:sp>
            <p:nvSpPr>
              <p:cNvPr id="43" name="文字方塊 42"/>
              <p:cNvSpPr txBox="1"/>
              <p:nvPr/>
            </p:nvSpPr>
            <p:spPr>
              <a:xfrm>
                <a:off x="6460393" y="1900091"/>
                <a:ext cx="37863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TW" sz="1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標楷體"/>
                    <a:cs typeface="Calibri" panose="020F0502020204030204" pitchFamily="34" charset="0"/>
                  </a:rPr>
                  <a:t>D)</a:t>
                </a:r>
                <a:endParaRPr kumimoji="0" lang="zh-TW" altLang="en-US" sz="1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標楷體"/>
                  <a:cs typeface="Calibri" panose="020F0502020204030204" pitchFamily="34" charset="0"/>
                </a:endParaRPr>
              </a:p>
            </p:txBody>
          </p:sp>
          <p:pic>
            <p:nvPicPr>
              <p:cNvPr id="10" name="圖片 9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6553453" y="1942779"/>
                <a:ext cx="5353708" cy="2237423"/>
              </a:xfrm>
              <a:prstGeom prst="rect">
                <a:avLst/>
              </a:prstGeom>
            </p:spPr>
          </p:pic>
        </p:grpSp>
        <p:grpSp>
          <p:nvGrpSpPr>
            <p:cNvPr id="12" name="群組 11"/>
            <p:cNvGrpSpPr/>
            <p:nvPr/>
          </p:nvGrpSpPr>
          <p:grpSpPr>
            <a:xfrm>
              <a:off x="920596" y="183111"/>
              <a:ext cx="5541329" cy="1295626"/>
              <a:chOff x="920596" y="183111"/>
              <a:chExt cx="5541329" cy="1295626"/>
            </a:xfrm>
          </p:grpSpPr>
          <p:sp>
            <p:nvSpPr>
              <p:cNvPr id="40" name="文字方塊 39"/>
              <p:cNvSpPr txBox="1"/>
              <p:nvPr/>
            </p:nvSpPr>
            <p:spPr>
              <a:xfrm>
                <a:off x="920596" y="183111"/>
                <a:ext cx="37382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TW" sz="1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標楷體"/>
                    <a:cs typeface="Calibri" panose="020F0502020204030204" pitchFamily="34" charset="0"/>
                  </a:rPr>
                  <a:t>A)</a:t>
                </a:r>
                <a:endParaRPr kumimoji="0" lang="zh-TW" altLang="en-US" sz="1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標楷體"/>
                  <a:cs typeface="Calibri" panose="020F0502020204030204" pitchFamily="34" charset="0"/>
                </a:endParaRPr>
              </a:p>
            </p:txBody>
          </p:sp>
          <p:pic>
            <p:nvPicPr>
              <p:cNvPr id="11" name="圖片 10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1000536" y="340656"/>
                <a:ext cx="5461389" cy="1138081"/>
              </a:xfrm>
              <a:prstGeom prst="rect">
                <a:avLst/>
              </a:prstGeom>
            </p:spPr>
          </p:pic>
        </p:grpSp>
        <p:sp>
          <p:nvSpPr>
            <p:cNvPr id="46" name="文字方塊 45"/>
            <p:cNvSpPr txBox="1"/>
            <p:nvPr/>
          </p:nvSpPr>
          <p:spPr>
            <a:xfrm>
              <a:off x="1891495" y="4341670"/>
              <a:ext cx="34817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標楷體"/>
                  <a:cs typeface="Calibri" panose="020F0502020204030204" pitchFamily="34" charset="0"/>
                </a:rPr>
                <a:t>E)</a:t>
              </a:r>
              <a:endParaRPr kumimoji="0" lang="zh-TW" altLang="en-US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標楷體"/>
                <a:cs typeface="Calibri" panose="020F0502020204030204" pitchFamily="34" charset="0"/>
              </a:endParaRPr>
            </a:p>
          </p:txBody>
        </p:sp>
        <p:pic>
          <p:nvPicPr>
            <p:cNvPr id="15" name="圖片 14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239667" y="4607947"/>
              <a:ext cx="7785609" cy="2069127"/>
            </a:xfrm>
            <a:prstGeom prst="rect">
              <a:avLst/>
            </a:prstGeom>
          </p:spPr>
        </p:pic>
        <p:pic>
          <p:nvPicPr>
            <p:cNvPr id="16" name="圖片 15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062957" y="2130552"/>
              <a:ext cx="4974990" cy="220344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644994190"/>
      </p:ext>
    </p:extLst>
  </p:cSld>
  <p:clrMapOvr>
    <a:masterClrMapping/>
  </p:clrMapOvr>
</p:sld>
</file>

<file path=ppt/theme/theme1.xml><?xml version="1.0" encoding="utf-8"?>
<a:theme xmlns:a="http://schemas.openxmlformats.org/drawingml/2006/main" name="3_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自訂 1">
      <a:majorFont>
        <a:latin typeface="Times New Roman"/>
        <a:ea typeface="標楷體"/>
        <a:cs typeface=""/>
      </a:majorFont>
      <a:minorFont>
        <a:latin typeface="Times New Roman"/>
        <a:ea typeface="標楷體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4576</TotalTime>
  <Words>41</Words>
  <Application>Microsoft Office PowerPoint</Application>
  <PresentationFormat>寬螢幕</PresentationFormat>
  <Paragraphs>9</Paragraphs>
  <Slides>2</Slides>
  <Notes>2</Notes>
  <HiddenSlides>0</HiddenSlides>
  <MMClips>0</MMClips>
  <ScaleCrop>false</ScaleCrop>
  <HeadingPairs>
    <vt:vector size="6" baseType="variant">
      <vt:variant>
        <vt:lpstr>使用字型</vt:lpstr>
      </vt:variant>
      <vt:variant>
        <vt:i4>5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2</vt:i4>
      </vt:variant>
    </vt:vector>
  </HeadingPairs>
  <TitlesOfParts>
    <vt:vector size="8" baseType="lpstr">
      <vt:lpstr>新細明體</vt:lpstr>
      <vt:lpstr>標楷體</vt:lpstr>
      <vt:lpstr>Arial</vt:lpstr>
      <vt:lpstr>Calibri</vt:lpstr>
      <vt:lpstr>Times New Roman</vt:lpstr>
      <vt:lpstr>3_Office 佈景主題</vt:lpstr>
      <vt:lpstr>PowerPoint 簡報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RP-OsGA3ox1 T0 Screening</dc:title>
  <dc:creator>陳良築</dc:creator>
  <cp:lastModifiedBy>ljchen</cp:lastModifiedBy>
  <cp:revision>548</cp:revision>
  <cp:lastPrinted>2022-11-05T13:28:51Z</cp:lastPrinted>
  <dcterms:created xsi:type="dcterms:W3CDTF">2021-06-02T06:35:22Z</dcterms:created>
  <dcterms:modified xsi:type="dcterms:W3CDTF">2023-09-27T03:01:52Z</dcterms:modified>
</cp:coreProperties>
</file>